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4" r:id="rId2"/>
    <p:sldId id="266" r:id="rId3"/>
    <p:sldId id="267" r:id="rId4"/>
    <p:sldId id="268" r:id="rId5"/>
    <p:sldId id="269" r:id="rId6"/>
    <p:sldId id="270" r:id="rId7"/>
  </p:sldIdLst>
  <p:sldSz cx="12192000" cy="16256000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45" d="100"/>
          <a:sy n="45" d="100"/>
        </p:scale>
        <p:origin x="1206" y="66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27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332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27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462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27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09140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27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1017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27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5178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27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5803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27/12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70898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27/12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2385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27/12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8874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27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9430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B6675-E010-4C41-BA87-77613E64EC47}" type="datetimeFigureOut">
              <a:rPr lang="en-GB" smtClean="0"/>
              <a:t>27/12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6317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9B6675-E010-4C41-BA87-77613E64EC47}" type="datetimeFigureOut">
              <a:rPr lang="en-GB" smtClean="0"/>
              <a:t>27/12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8AEC4C-5647-4BC6-9134-23EA76D5D8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2836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053935" y="1320908"/>
            <a:ext cx="1027215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GB" b="1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analysis of 19 </a:t>
            </a:r>
            <a:r>
              <a:rPr lang="en-US" altLang="ko-KR" i="1">
                <a:latin typeface="Times New Roman" panose="02020603050405020304" pitchFamily="18" charset="0"/>
                <a:cs typeface="Times New Roman" panose="02020603050405020304" pitchFamily="18" charset="0"/>
              </a:rPr>
              <a:t>Vicia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species based on the nucleotide sequences of the ITS2</a:t>
            </a:r>
            <a:r>
              <a:rPr lang="en-US" altLang="ko-KR" i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region.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670" y="1929119"/>
            <a:ext cx="10269421" cy="14326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06765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053935" y="1320908"/>
            <a:ext cx="1027215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analysis of 19 </a:t>
            </a:r>
            <a:r>
              <a:rPr lang="en-US" altLang="ko-KR" i="1">
                <a:latin typeface="Times New Roman" panose="02020603050405020304" pitchFamily="18" charset="0"/>
                <a:cs typeface="Times New Roman" panose="02020603050405020304" pitchFamily="18" charset="0"/>
              </a:rPr>
              <a:t>Vicia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species based on the nucleotide sequences of the </a:t>
            </a:r>
            <a:r>
              <a:rPr lang="en-US" altLang="ko-KR" i="1">
                <a:latin typeface="Times New Roman" panose="02020603050405020304" pitchFamily="18" charset="0"/>
                <a:cs typeface="Times New Roman" panose="02020603050405020304" pitchFamily="18" charset="0"/>
              </a:rPr>
              <a:t>matK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region.</a:t>
            </a:r>
            <a:endParaRPr lang="en-GB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451" y="1925303"/>
            <a:ext cx="10272156" cy="143306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75042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053935" y="1320908"/>
            <a:ext cx="1027215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1"/>
            <a:r>
              <a:rPr lang="en-GB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.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analysis of 19 </a:t>
            </a:r>
            <a:r>
              <a:rPr lang="en-US" altLang="ko-KR" i="1">
                <a:latin typeface="Times New Roman" panose="02020603050405020304" pitchFamily="18" charset="0"/>
                <a:cs typeface="Times New Roman" panose="02020603050405020304" pitchFamily="18" charset="0"/>
              </a:rPr>
              <a:t>Vicia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species based on the nucleotide sequences of the </a:t>
            </a:r>
            <a:r>
              <a:rPr lang="en-US" altLang="ko-KR" i="1">
                <a:latin typeface="Times New Roman" panose="02020603050405020304" pitchFamily="18" charset="0"/>
                <a:cs typeface="Times New Roman" panose="02020603050405020304" pitchFamily="18" charset="0"/>
              </a:rPr>
              <a:t>rbcL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region.</a:t>
            </a:r>
            <a:endParaRPr lang="ko-KR" altLang="ko-K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507" y="1881949"/>
            <a:ext cx="10303232" cy="14374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74336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053934" y="1320908"/>
            <a:ext cx="107461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1"/>
            <a:r>
              <a:rPr lang="en-GB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</a:t>
            </a:r>
            <a:r>
              <a:rPr lang="en-US" altLang="ko-KR"/>
              <a:t> analysis of 19 </a:t>
            </a:r>
            <a:r>
              <a:rPr lang="en-US" altLang="ko-KR" i="1"/>
              <a:t>Vicia </a:t>
            </a:r>
            <a:r>
              <a:rPr lang="en-US" altLang="ko-KR"/>
              <a:t>species based on the nucleotide sequences of the ITS2+</a:t>
            </a:r>
            <a:r>
              <a:rPr lang="en-US" altLang="ko-KR" i="1"/>
              <a:t>matK </a:t>
            </a:r>
            <a:r>
              <a:rPr lang="en-US" altLang="ko-KR"/>
              <a:t>region.</a:t>
            </a:r>
            <a:endParaRPr lang="ko-KR" altLang="ko-KR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244" y="1750419"/>
            <a:ext cx="10397512" cy="145055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21400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053934" y="1320908"/>
            <a:ext cx="107461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1"/>
            <a:r>
              <a:rPr lang="en-GB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altLang="ko-KR"/>
              <a:t>Phylogenetic analysis of 19 </a:t>
            </a:r>
            <a:r>
              <a:rPr lang="en-US" altLang="ko-KR" i="1"/>
              <a:t>Vicia </a:t>
            </a:r>
            <a:r>
              <a:rPr lang="en-US" altLang="ko-KR"/>
              <a:t>species based on the nucleotide sequences of the ITS2+</a:t>
            </a:r>
            <a:r>
              <a:rPr lang="en-US" altLang="ko-KR" i="1"/>
              <a:t>rbcL </a:t>
            </a:r>
            <a:r>
              <a:rPr lang="en-US" altLang="ko-KR"/>
              <a:t>region.</a:t>
            </a:r>
            <a:endParaRPr lang="ko-KR" altLang="ko-KR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9898" y="1824839"/>
            <a:ext cx="10344168" cy="144311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94174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053934" y="1320908"/>
            <a:ext cx="10746179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atinLnBrk="1"/>
            <a:r>
              <a:rPr lang="en-GB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. </a:t>
            </a:r>
            <a:r>
              <a:rPr lang="en-US" altLang="ko-KR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</a:t>
            </a:r>
            <a:r>
              <a:rPr lang="en-US" altLang="ko-KR"/>
              <a:t> analysis of 19 </a:t>
            </a:r>
            <a:r>
              <a:rPr lang="en-US" altLang="ko-KR" i="1"/>
              <a:t>Vicia </a:t>
            </a:r>
            <a:r>
              <a:rPr lang="en-US" altLang="ko-KR"/>
              <a:t>species based on the nucleotide sequences of the </a:t>
            </a:r>
            <a:r>
              <a:rPr lang="en-US" altLang="ko-KR" i="1"/>
              <a:t>matK</a:t>
            </a:r>
            <a:r>
              <a:rPr lang="en-US" altLang="ko-KR"/>
              <a:t>+</a:t>
            </a:r>
            <a:r>
              <a:rPr lang="en-US" altLang="ko-KR" i="1"/>
              <a:t>rbcL </a:t>
            </a:r>
            <a:r>
              <a:rPr lang="en-US" altLang="ko-KR"/>
              <a:t>region.</a:t>
            </a:r>
            <a:endParaRPr lang="ko-KR" altLang="ko-KR"/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469" y="1859753"/>
            <a:ext cx="10142330" cy="141495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3201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5</TotalTime>
  <Words>114</Words>
  <Application>Microsoft Office PowerPoint</Application>
  <PresentationFormat>사용자 지정</PresentationFormat>
  <Paragraphs>6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Times New Roman</vt:lpstr>
      <vt:lpstr>Office Them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</dc:creator>
  <cp:lastModifiedBy>han seahee</cp:lastModifiedBy>
  <cp:revision>34</cp:revision>
  <cp:lastPrinted>2020-03-27T00:33:21Z</cp:lastPrinted>
  <dcterms:created xsi:type="dcterms:W3CDTF">2020-03-17T08:41:47Z</dcterms:created>
  <dcterms:modified xsi:type="dcterms:W3CDTF">2020-12-27T14:13:17Z</dcterms:modified>
</cp:coreProperties>
</file>